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66A34B-BEA4-423B-9AEE-13465A7224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65A81-B1B3-4086-99D9-0EAFA769D11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EE9F77-DF74-4ABD-B058-89E4523FFB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47D3B-D1CF-46AC-BD6F-E4ABDB9BE41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363C2-E918-47E0-807D-571599D90E4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9B14D-C5C8-4703-99C3-126103E6F6A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F42B9-5DA3-417D-86D3-4FDF91BFE2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0AF1C4-C2CC-458F-BF07-52DD6E3E6F7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9459AE-70D0-4A34-AD7D-A1E73E905B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28FC26-CD94-45EA-8FEF-658ED56EDD8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C8EDFD-C731-46D0-8F2B-56A91121C3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EF947C-C377-44A5-ABFD-875486525A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FFDDF35-7722-4636-B461-083CCD92771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419120" y="14209560"/>
            <a:ext cx="3079800" cy="109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200" spc="-1" strike="noStrike">
                <a:solidFill>
                  <a:srgbClr val="000000"/>
                </a:solidFill>
                <a:latin typeface="Arial"/>
              </a:rPr>
              <a:t>Figure 2.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K-means clustering of differentially expressed genes in all of the comparisons according to expression profiles. Each comparison is arranged into vertical columns in the following order: column 1, </a:t>
            </a:r>
            <a:r>
              <a:rPr b="0" i="1" lang="de-DE" sz="1200" spc="-1" strike="noStrike">
                <a:solidFill>
                  <a:srgbClr val="000000"/>
                </a:solidFill>
                <a:latin typeface="Arial"/>
              </a:rPr>
              <a:t>AtHb1 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overexpression versus wild type under control conditions; column 2, comparison of both genotypes under hypoxic conditions; column 3, wild type under hypoxia versus wild type under normoxia; column 4, transgenic under hypoxia versus transgenic under normoxia. Columns 2 and 3 are separated by grey column. A total of 1011 genes was extracted from the data base by applying a fold-change of &gt;2 (log</a:t>
            </a:r>
            <a:r>
              <a:rPr b="0" lang="de-DE" sz="1200" spc="-1" strike="noStrike" baseline="-25000">
                <a:solidFill>
                  <a:srgbClr val="000000"/>
                </a:solidFill>
                <a:latin typeface="Arial"/>
              </a:rPr>
              <a:t>2</a:t>
            </a:r>
            <a:r>
              <a:rPr b="0" lang="de-DE" sz="1200" spc="-1" strike="noStrike">
                <a:solidFill>
                  <a:srgbClr val="000000"/>
                </a:solidFill>
                <a:latin typeface="Arial"/>
              </a:rPr>
              <a:t> &gt;1) and a p-value of &lt;0.05 in all of the comparisons. Columns indicate the number of genes (no. Genes) per cluster, colours indicate inreased (yellow), decreased (blue) or unchanged expression (black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>
            <a:lum bright="6000"/>
          </a:blip>
          <a:stretch/>
        </p:blipFill>
        <p:spPr>
          <a:xfrm>
            <a:off x="1125360" y="539640"/>
            <a:ext cx="2140200" cy="81727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7-26T10:08:33Z</dcterms:created>
  <dc:creator>rollet</dc:creator>
  <dc:description/>
  <dc:language>en-US</dc:language>
  <cp:lastModifiedBy>rollet</cp:lastModifiedBy>
  <dcterms:modified xsi:type="dcterms:W3CDTF">2011-03-01T12:42:46Z</dcterms:modified>
  <cp:revision>6</cp:revision>
  <dc:subject/>
  <dc:title>Folie 1</dc:title>
</cp:coreProperties>
</file>